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6" r:id="rId2"/>
    <p:sldId id="271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158" autoAdjust="0"/>
    <p:restoredTop sz="94660"/>
  </p:normalViewPr>
  <p:slideViewPr>
    <p:cSldViewPr snapToGrid="0">
      <p:cViewPr varScale="1">
        <p:scale>
          <a:sx n="90" d="100"/>
          <a:sy n="90" d="100"/>
        </p:scale>
        <p:origin x="113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A3DB12-1D12-4D20-B89C-F89DE4958E7B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4CB7BB-CD8E-4B63-A6D5-C562D7E76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720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875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200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368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505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532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989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770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373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341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328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657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5F9220-FFFB-4702-8A8B-FA9251FA891D}" type="datetimeFigureOut">
              <a:rPr lang="en-US" smtClean="0"/>
              <a:t>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A369F-891D-463A-B0BD-D1AEFD7920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340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090" y="808915"/>
            <a:ext cx="5379124" cy="309602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785" y="4295310"/>
            <a:ext cx="5445162" cy="311732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80179" y="7474862"/>
            <a:ext cx="5600700" cy="10804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200" b="1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Supplementary Figure 1.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Kaplan-Meier Plots of overall survival (OS) for </a:t>
            </a:r>
            <a:r>
              <a:rPr lang="en-CA" sz="1200" b="1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(A)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HPV-negative HNSCC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patients stratified by ZNF154 expression, </a:t>
            </a:r>
            <a:r>
              <a:rPr lang="en-CA" sz="1200" b="1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(B)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HPV-negative HNSCC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patients stratified by ZNF132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expression.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The red lines indicate low expressors; the green lines indicate high expressors. Difference in survival between patient groups were assessed by Log-rank statistic.</a:t>
            </a:r>
            <a:endParaRPr lang="en-CA" sz="1200" dirty="0">
              <a:latin typeface="Calibri" panose="020F0502020204030204" pitchFamily="34" charset="0"/>
              <a:ea typeface="Calibri" panose="020F0502020204030204" pitchFamily="34" charset="0"/>
              <a:cs typeface="Mang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726870" y="326571"/>
            <a:ext cx="2253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648032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925370"/>
            <a:ext cx="5804515" cy="395143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86415" y="5468262"/>
            <a:ext cx="5600700" cy="12780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A" sz="1200" b="1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Supplementary Figure </a:t>
            </a:r>
            <a:r>
              <a:rPr lang="en-CA" sz="1200" b="1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2.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Kaplan-Meier Plots of overall survival (OS) for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53 larynx cancer cases derived from the Albert Einstein College of Medicine Head and Neck Cancer database. stratified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by ZNF154 expression, </a:t>
            </a:r>
            <a:r>
              <a:rPr lang="en-CA" sz="1200" b="1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(B)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HPV-negative HNSCC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patients stratified by ZNF132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expression.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The red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line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indicate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low ZNF154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expressors; the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teal line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indicate high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ZNF154 expressors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. Difference in survival between patient groups </a:t>
            </a:r>
            <a:r>
              <a:rPr lang="en-CA" sz="1200" dirty="0" smtClean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was </a:t>
            </a:r>
            <a:r>
              <a:rPr lang="en-CA" sz="1200" dirty="0">
                <a:latin typeface="Arial" panose="020B0604020202020204" pitchFamily="34" charset="0"/>
                <a:ea typeface="Arial" panose="020B0604020202020204" pitchFamily="34" charset="0"/>
                <a:cs typeface="Mangal"/>
              </a:rPr>
              <a:t>assessed by Log-rank statistic.</a:t>
            </a:r>
            <a:endParaRPr lang="en-CA" sz="1200" dirty="0">
              <a:latin typeface="Calibri" panose="020F0502020204030204" pitchFamily="34" charset="0"/>
              <a:ea typeface="Calibri" panose="020F0502020204030204" pitchFamily="34" charset="0"/>
              <a:cs typeface="Mangal"/>
            </a:endParaRPr>
          </a:p>
        </p:txBody>
      </p:sp>
    </p:spTree>
    <p:extLst>
      <p:ext uri="{BB962C8B-B14F-4D97-AF65-F5344CB8AC3E}">
        <p14:creationId xmlns:p14="http://schemas.microsoft.com/office/powerpoint/2010/main" val="1965355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6</TotalTime>
  <Words>139</Words>
  <Application>Microsoft Office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Mangal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Belbin</dc:creator>
  <cp:lastModifiedBy>Belbin, Thomas James</cp:lastModifiedBy>
  <cp:revision>61</cp:revision>
  <dcterms:created xsi:type="dcterms:W3CDTF">2021-07-21T17:12:37Z</dcterms:created>
  <dcterms:modified xsi:type="dcterms:W3CDTF">2023-02-18T17:32:58Z</dcterms:modified>
</cp:coreProperties>
</file>